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52424-5281-409A-AFC5-62A648AF3F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826DB-D875-46F8-96B1-A4E9E59614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89083-A354-4A39-9FCC-1A659A834B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152C6-686E-43B7-96DC-8663CB4887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56A3E-5631-403F-9295-3BE4215DFE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F9AB43-C978-4303-9D84-15A8E4F27E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36B05-6433-4956-96E2-786EC007D5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A2A5FD-1E1A-4245-AEA4-5DFC45EA9F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F4192-8CD0-40CA-A1C5-7BD7006F76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4AFB9-D45D-4A97-9DCD-AA8225F626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C1E073-3A5A-4EDD-81B3-EFC4261D8D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4F1E6-B7E3-436A-A0EE-3B02C084E4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EA3BFE-728D-480F-A910-CD8D6F31A05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6" descr="myc_pos_bcl6.tif"/>
          <p:cNvPicPr/>
          <p:nvPr/>
        </p:nvPicPr>
        <p:blipFill>
          <a:blip r:embed="rId1"/>
          <a:srcRect l="0" t="7148" r="2356" b="959"/>
          <a:stretch/>
        </p:blipFill>
        <p:spPr>
          <a:xfrm>
            <a:off x="3645000" y="1271520"/>
            <a:ext cx="2952720" cy="19670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5" descr="myc_pos_bcl2.tif"/>
          <p:cNvPicPr/>
          <p:nvPr/>
        </p:nvPicPr>
        <p:blipFill>
          <a:blip r:embed="rId2"/>
          <a:srcRect l="0" t="8577" r="3039" b="1438"/>
          <a:stretch/>
        </p:blipFill>
        <p:spPr>
          <a:xfrm>
            <a:off x="617400" y="1289160"/>
            <a:ext cx="2916360" cy="1914480"/>
          </a:xfrm>
          <a:prstGeom prst="rect">
            <a:avLst/>
          </a:prstGeom>
          <a:ln w="0">
            <a:noFill/>
          </a:ln>
        </p:spPr>
      </p:pic>
      <p:sp>
        <p:nvSpPr>
          <p:cNvPr id="43" name="TextBox 6"/>
          <p:cNvSpPr/>
          <p:nvPr/>
        </p:nvSpPr>
        <p:spPr>
          <a:xfrm>
            <a:off x="476280" y="5724360"/>
            <a:ext cx="6121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Supplementary Figure S2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. Impact of 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TP53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mutation,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BCL2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BCL6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translocation on overall survival of patients with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MYC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translocation positive DLBC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rans+ve: translocation positive;  trans-ve: translocation negativ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4724280" y="2556000"/>
            <a:ext cx="1800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Cox regression adjusted for 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Hazard ratio: 0.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Confidence interval: 0.048, 0.8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6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 = 0.03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345960" y="900000"/>
            <a:ext cx="50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3789360" y="900000"/>
            <a:ext cx="50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2"/>
          <p:cNvSpPr/>
          <p:nvPr/>
        </p:nvSpPr>
        <p:spPr>
          <a:xfrm>
            <a:off x="345960" y="3233880"/>
            <a:ext cx="50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10" descr="myc_pos_p53.tif"/>
          <p:cNvPicPr/>
          <p:nvPr/>
        </p:nvPicPr>
        <p:blipFill>
          <a:blip r:embed="rId3"/>
          <a:srcRect l="0" t="8104" r="2696" b="947"/>
          <a:stretch/>
        </p:blipFill>
        <p:spPr>
          <a:xfrm>
            <a:off x="600120" y="3357720"/>
            <a:ext cx="2925720" cy="1935000"/>
          </a:xfrm>
          <a:prstGeom prst="rect">
            <a:avLst/>
          </a:prstGeom>
          <a:ln w="0">
            <a:noFill/>
          </a:ln>
        </p:spPr>
      </p:pic>
      <p:sp>
        <p:nvSpPr>
          <p:cNvPr id="49" name="TextBox 11"/>
          <p:cNvSpPr/>
          <p:nvPr/>
        </p:nvSpPr>
        <p:spPr>
          <a:xfrm>
            <a:off x="1700280" y="4599000"/>
            <a:ext cx="1800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Cox regression adjusted for ag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Hazard ratio: 2.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Confidence interval: 1.05, 5.0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6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600" spc="-1" strike="noStrike">
                <a:solidFill>
                  <a:srgbClr val="000000"/>
                </a:solidFill>
                <a:latin typeface="Calibri"/>
              </a:rPr>
              <a:t> = 0.03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4T14:44:09Z</dcterms:created>
  <dc:creator>Ming</dc:creator>
  <dc:description/>
  <dc:language>en-US</dc:language>
  <cp:lastModifiedBy>   </cp:lastModifiedBy>
  <dcterms:modified xsi:type="dcterms:W3CDTF">2014-09-23T17:11:55Z</dcterms:modified>
  <cp:revision>63</cp:revision>
  <dc:subject/>
  <dc:title>Slide 1</dc:title>
</cp:coreProperties>
</file>